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59" d="100"/>
          <a:sy n="59" d="100"/>
        </p:scale>
        <p:origin x="2366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2A5751-937D-4A8E-A125-5BC7C31039DC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EB7551-501F-4239-893B-96DA5FBC0D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2897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72C19-DDF5-40C3-9C21-7533156ADCE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BBCFC-75BC-497D-9C0E-5666BA6C9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015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72C19-DDF5-40C3-9C21-7533156ADCE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BBCFC-75BC-497D-9C0E-5666BA6C9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02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72C19-DDF5-40C3-9C21-7533156ADCE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BBCFC-75BC-497D-9C0E-5666BA6C9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989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72C19-DDF5-40C3-9C21-7533156ADCE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BBCFC-75BC-497D-9C0E-5666BA6C9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050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72C19-DDF5-40C3-9C21-7533156ADCE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BBCFC-75BC-497D-9C0E-5666BA6C9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222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72C19-DDF5-40C3-9C21-7533156ADCE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BBCFC-75BC-497D-9C0E-5666BA6C9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995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72C19-DDF5-40C3-9C21-7533156ADCE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BBCFC-75BC-497D-9C0E-5666BA6C9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180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72C19-DDF5-40C3-9C21-7533156ADCE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BBCFC-75BC-497D-9C0E-5666BA6C9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462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72C19-DDF5-40C3-9C21-7533156ADCE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BBCFC-75BC-497D-9C0E-5666BA6C9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779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72C19-DDF5-40C3-9C21-7533156ADCE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BBCFC-75BC-497D-9C0E-5666BA6C9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249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72C19-DDF5-40C3-9C21-7533156ADCE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BBCFC-75BC-497D-9C0E-5666BA6C9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4422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72C19-DDF5-40C3-9C21-7533156ADCE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6BBCFC-75BC-497D-9C0E-5666BA6C9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5699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TextBox 72"/>
          <p:cNvSpPr txBox="1"/>
          <p:nvPr/>
        </p:nvSpPr>
        <p:spPr>
          <a:xfrm>
            <a:off x="5438322" y="51129"/>
            <a:ext cx="1554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 Black" panose="020B0A04020102020204" pitchFamily="34" charset="0"/>
              </a:rPr>
              <a:t>Figure S2</a:t>
            </a:r>
          </a:p>
        </p:txBody>
      </p:sp>
      <p:grpSp>
        <p:nvGrpSpPr>
          <p:cNvPr id="13" name="Group 12"/>
          <p:cNvGrpSpPr/>
          <p:nvPr/>
        </p:nvGrpSpPr>
        <p:grpSpPr>
          <a:xfrm>
            <a:off x="24636" y="541135"/>
            <a:ext cx="6815208" cy="3085650"/>
            <a:chOff x="231355" y="3475730"/>
            <a:chExt cx="11450877" cy="3648346"/>
          </a:xfrm>
        </p:grpSpPr>
        <p:grpSp>
          <p:nvGrpSpPr>
            <p:cNvPr id="19" name="Group 18"/>
            <p:cNvGrpSpPr/>
            <p:nvPr/>
          </p:nvGrpSpPr>
          <p:grpSpPr>
            <a:xfrm>
              <a:off x="231355" y="3475730"/>
              <a:ext cx="11450877" cy="3648346"/>
              <a:chOff x="0" y="2765155"/>
              <a:chExt cx="11450877" cy="3648346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3846"/>
              <a:stretch/>
            </p:blipFill>
            <p:spPr>
              <a:xfrm>
                <a:off x="7656606" y="2765155"/>
                <a:ext cx="3794271" cy="3648345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51"/>
              <a:stretch/>
            </p:blipFill>
            <p:spPr>
              <a:xfrm>
                <a:off x="0" y="2765157"/>
                <a:ext cx="3802365" cy="3648343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59"/>
              <a:stretch/>
            </p:blipFill>
            <p:spPr>
              <a:xfrm>
                <a:off x="3827765" y="2773251"/>
                <a:ext cx="3794271" cy="3640250"/>
              </a:xfrm>
              <a:prstGeom prst="rect">
                <a:avLst/>
              </a:prstGeom>
            </p:spPr>
          </p:pic>
        </p:grpSp>
        <p:grpSp>
          <p:nvGrpSpPr>
            <p:cNvPr id="31" name="Group 30"/>
            <p:cNvGrpSpPr/>
            <p:nvPr/>
          </p:nvGrpSpPr>
          <p:grpSpPr>
            <a:xfrm>
              <a:off x="2947594" y="6709195"/>
              <a:ext cx="1008531" cy="340672"/>
              <a:chOff x="2490310" y="5551386"/>
              <a:chExt cx="1008531" cy="340672"/>
            </a:xfrm>
          </p:grpSpPr>
          <p:sp>
            <p:nvSpPr>
              <p:cNvPr id="29" name="TextBox 28"/>
              <p:cNvSpPr txBox="1"/>
              <p:nvPr/>
            </p:nvSpPr>
            <p:spPr>
              <a:xfrm flipH="1">
                <a:off x="2490310" y="5551386"/>
                <a:ext cx="1008531" cy="3239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µm</a:t>
                </a:r>
              </a:p>
            </p:txBody>
          </p:sp>
          <p:cxnSp>
            <p:nvCxnSpPr>
              <p:cNvPr id="30" name="Straight Connector 29"/>
              <p:cNvCxnSpPr/>
              <p:nvPr/>
            </p:nvCxnSpPr>
            <p:spPr>
              <a:xfrm>
                <a:off x="2860828" y="5885708"/>
                <a:ext cx="292099" cy="635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 31"/>
            <p:cNvGrpSpPr/>
            <p:nvPr/>
          </p:nvGrpSpPr>
          <p:grpSpPr>
            <a:xfrm>
              <a:off x="6949112" y="6759104"/>
              <a:ext cx="1085048" cy="323981"/>
              <a:chOff x="2812138" y="5616467"/>
              <a:chExt cx="1085048" cy="323981"/>
            </a:xfrm>
          </p:grpSpPr>
          <p:sp>
            <p:nvSpPr>
              <p:cNvPr id="33" name="TextBox 32"/>
              <p:cNvSpPr txBox="1"/>
              <p:nvPr/>
            </p:nvSpPr>
            <p:spPr>
              <a:xfrm flipH="1">
                <a:off x="2812138" y="5616467"/>
                <a:ext cx="1085048" cy="3239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µm</a:t>
                </a:r>
              </a:p>
            </p:txBody>
          </p:sp>
          <p:cxnSp>
            <p:nvCxnSpPr>
              <p:cNvPr id="34" name="Straight Connector 33"/>
              <p:cNvCxnSpPr/>
              <p:nvPr/>
            </p:nvCxnSpPr>
            <p:spPr>
              <a:xfrm>
                <a:off x="3129656" y="5927606"/>
                <a:ext cx="292100" cy="635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 34"/>
            <p:cNvGrpSpPr/>
            <p:nvPr/>
          </p:nvGrpSpPr>
          <p:grpSpPr>
            <a:xfrm>
              <a:off x="10743384" y="6722078"/>
              <a:ext cx="934602" cy="339908"/>
              <a:chOff x="2845893" y="5594048"/>
              <a:chExt cx="934602" cy="339908"/>
            </a:xfrm>
          </p:grpSpPr>
          <p:sp>
            <p:nvSpPr>
              <p:cNvPr id="36" name="TextBox 35"/>
              <p:cNvSpPr txBox="1"/>
              <p:nvPr/>
            </p:nvSpPr>
            <p:spPr>
              <a:xfrm flipH="1">
                <a:off x="2845893" y="5594048"/>
                <a:ext cx="934602" cy="3239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µm</a:t>
                </a:r>
              </a:p>
            </p:txBody>
          </p:sp>
          <p:cxnSp>
            <p:nvCxnSpPr>
              <p:cNvPr id="37" name="Straight Connector 36"/>
              <p:cNvCxnSpPr/>
              <p:nvPr/>
            </p:nvCxnSpPr>
            <p:spPr>
              <a:xfrm>
                <a:off x="3129656" y="5927606"/>
                <a:ext cx="292100" cy="635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" name="TextBox 1"/>
            <p:cNvSpPr txBox="1"/>
            <p:nvPr/>
          </p:nvSpPr>
          <p:spPr>
            <a:xfrm>
              <a:off x="1119117" y="4599295"/>
              <a:ext cx="706517" cy="420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bg1"/>
                  </a:solidFill>
                </a:rPr>
                <a:t>cv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364345" y="5079563"/>
              <a:ext cx="965591" cy="46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chemeClr val="bg1"/>
                  </a:solidFill>
                </a:rPr>
                <a:t>cv</a:t>
              </a: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1931339" y="5448895"/>
              <a:ext cx="685948" cy="618544"/>
              <a:chOff x="1931339" y="5448895"/>
              <a:chExt cx="685948" cy="618544"/>
            </a:xfrm>
          </p:grpSpPr>
          <p:sp>
            <p:nvSpPr>
              <p:cNvPr id="62" name="TextBox 61"/>
              <p:cNvSpPr txBox="1"/>
              <p:nvPr/>
            </p:nvSpPr>
            <p:spPr>
              <a:xfrm>
                <a:off x="1931339" y="5689390"/>
                <a:ext cx="685948" cy="3780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EB</a:t>
                </a:r>
              </a:p>
            </p:txBody>
          </p:sp>
          <p:cxnSp>
            <p:nvCxnSpPr>
              <p:cNvPr id="4" name="Straight Arrow Connector 3"/>
              <p:cNvCxnSpPr/>
              <p:nvPr/>
            </p:nvCxnSpPr>
            <p:spPr>
              <a:xfrm flipV="1">
                <a:off x="2128029" y="5448895"/>
                <a:ext cx="68648" cy="248042"/>
              </a:xfrm>
              <a:prstGeom prst="straightConnector1">
                <a:avLst/>
              </a:prstGeom>
              <a:ln w="9525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3" name="Group 62"/>
            <p:cNvGrpSpPr/>
            <p:nvPr/>
          </p:nvGrpSpPr>
          <p:grpSpPr>
            <a:xfrm>
              <a:off x="5183178" y="5163829"/>
              <a:ext cx="641016" cy="344211"/>
              <a:chOff x="1958635" y="5525613"/>
              <a:chExt cx="641016" cy="344211"/>
            </a:xfrm>
          </p:grpSpPr>
          <p:sp>
            <p:nvSpPr>
              <p:cNvPr id="64" name="TextBox 63"/>
              <p:cNvSpPr txBox="1"/>
              <p:nvPr/>
            </p:nvSpPr>
            <p:spPr>
              <a:xfrm>
                <a:off x="1958635" y="5525613"/>
                <a:ext cx="641016" cy="3442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CS</a:t>
                </a:r>
              </a:p>
            </p:txBody>
          </p:sp>
          <p:cxnSp>
            <p:nvCxnSpPr>
              <p:cNvPr id="65" name="Straight Arrow Connector 64"/>
              <p:cNvCxnSpPr/>
              <p:nvPr/>
            </p:nvCxnSpPr>
            <p:spPr>
              <a:xfrm>
                <a:off x="2340771" y="5723927"/>
                <a:ext cx="204288" cy="86751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6" name="TextBox 65"/>
            <p:cNvSpPr txBox="1"/>
            <p:nvPr/>
          </p:nvSpPr>
          <p:spPr>
            <a:xfrm>
              <a:off x="5026621" y="4510016"/>
              <a:ext cx="742980" cy="3824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bg1"/>
                  </a:solidFill>
                </a:rPr>
                <a:t>cv</a:t>
              </a:r>
            </a:p>
          </p:txBody>
        </p:sp>
        <p:grpSp>
          <p:nvGrpSpPr>
            <p:cNvPr id="67" name="Group 66"/>
            <p:cNvGrpSpPr/>
            <p:nvPr/>
          </p:nvGrpSpPr>
          <p:grpSpPr>
            <a:xfrm>
              <a:off x="9032041" y="5105130"/>
              <a:ext cx="586424" cy="344211"/>
              <a:chOff x="1958635" y="5525613"/>
              <a:chExt cx="586424" cy="344211"/>
            </a:xfrm>
          </p:grpSpPr>
          <p:sp>
            <p:nvSpPr>
              <p:cNvPr id="68" name="TextBox 67"/>
              <p:cNvSpPr txBox="1"/>
              <p:nvPr/>
            </p:nvSpPr>
            <p:spPr>
              <a:xfrm>
                <a:off x="1958635" y="5525613"/>
                <a:ext cx="586424" cy="3442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EB</a:t>
                </a:r>
                <a:endParaRPr lang="en-US" sz="26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69" name="Straight Arrow Connector 68"/>
              <p:cNvCxnSpPr/>
              <p:nvPr/>
            </p:nvCxnSpPr>
            <p:spPr>
              <a:xfrm>
                <a:off x="2340771" y="5723927"/>
                <a:ext cx="204288" cy="86751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0" name="Group 69"/>
            <p:cNvGrpSpPr/>
            <p:nvPr/>
          </p:nvGrpSpPr>
          <p:grpSpPr>
            <a:xfrm>
              <a:off x="9516324" y="5825286"/>
              <a:ext cx="586422" cy="344211"/>
              <a:chOff x="1958638" y="5525614"/>
              <a:chExt cx="586422" cy="344211"/>
            </a:xfrm>
          </p:grpSpPr>
          <p:sp>
            <p:nvSpPr>
              <p:cNvPr id="71" name="TextBox 70"/>
              <p:cNvSpPr txBox="1"/>
              <p:nvPr/>
            </p:nvSpPr>
            <p:spPr>
              <a:xfrm>
                <a:off x="1958638" y="5525614"/>
                <a:ext cx="586422" cy="3442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CS</a:t>
                </a:r>
              </a:p>
            </p:txBody>
          </p:sp>
          <p:cxnSp>
            <p:nvCxnSpPr>
              <p:cNvPr id="72" name="Straight Arrow Connector 71"/>
              <p:cNvCxnSpPr/>
              <p:nvPr/>
            </p:nvCxnSpPr>
            <p:spPr>
              <a:xfrm>
                <a:off x="2340771" y="5723927"/>
                <a:ext cx="204288" cy="86751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0" name="TextBox 39"/>
          <p:cNvSpPr txBox="1"/>
          <p:nvPr/>
        </p:nvSpPr>
        <p:spPr>
          <a:xfrm>
            <a:off x="-20704" y="602009"/>
            <a:ext cx="2437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 Black" panose="020B0A04020102020204" pitchFamily="34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294177" y="588607"/>
            <a:ext cx="2372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 Black" panose="020B0A04020102020204" pitchFamily="34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42" name="TextBox 41"/>
          <p:cNvSpPr txBox="1"/>
          <p:nvPr/>
        </p:nvSpPr>
        <p:spPr>
          <a:xfrm flipH="1">
            <a:off x="4580096" y="578260"/>
            <a:ext cx="563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 Black" panose="020B0A04020102020204" pitchFamily="34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2D3AE1F-4E1D-358D-2ED2-325424777D0B}"/>
              </a:ext>
            </a:extLst>
          </p:cNvPr>
          <p:cNvSpPr txBox="1"/>
          <p:nvPr/>
        </p:nvSpPr>
        <p:spPr>
          <a:xfrm>
            <a:off x="0" y="3747046"/>
            <a:ext cx="68989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 Black" panose="020B0A04020102020204" pitchFamily="34" charset="0"/>
                <a:cs typeface="Arial" panose="020B0604020202020204" pitchFamily="34" charset="0"/>
              </a:rPr>
              <a:t> Endophytic </a:t>
            </a:r>
            <a:r>
              <a:rPr lang="en-US" sz="1100" b="1">
                <a:latin typeface="Arial Black" panose="020B0A04020102020204" pitchFamily="34" charset="0"/>
                <a:cs typeface="Arial" panose="020B0604020202020204" pitchFamily="34" charset="0"/>
              </a:rPr>
              <a:t>Bacteria                   </a:t>
            </a:r>
            <a:r>
              <a:rPr lang="en-US" sz="1100" b="1" dirty="0">
                <a:latin typeface="Arial Black" panose="020B0A04020102020204" pitchFamily="34" charset="0"/>
                <a:cs typeface="Arial" panose="020B0604020202020204" pitchFamily="34" charset="0"/>
              </a:rPr>
              <a:t>Inter-Vacuolar Strand                    Merged image 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   </a:t>
            </a:r>
          </a:p>
        </p:txBody>
      </p:sp>
    </p:spTree>
    <p:extLst>
      <p:ext uri="{BB962C8B-B14F-4D97-AF65-F5344CB8AC3E}">
        <p14:creationId xmlns:p14="http://schemas.microsoft.com/office/powerpoint/2010/main" val="1883821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19</TotalTime>
  <Words>22</Words>
  <Application>Microsoft Office PowerPoint</Application>
  <PresentationFormat>A4 Paper (210x297 mm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Black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d shadab</dc:creator>
  <cp:lastModifiedBy>mohd shadab</cp:lastModifiedBy>
  <cp:revision>86</cp:revision>
  <dcterms:created xsi:type="dcterms:W3CDTF">2019-11-15T07:10:57Z</dcterms:created>
  <dcterms:modified xsi:type="dcterms:W3CDTF">2025-01-29T03:22:39Z</dcterms:modified>
</cp:coreProperties>
</file>